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6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38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8388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92236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0592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93486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27528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60949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88641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4442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039853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60652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85460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04813-26D4-4E28-901C-0A2FD384071F}" type="datetimeFigureOut">
              <a:rPr lang="en-IE" smtClean="0"/>
              <a:t>21/02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5136C-CAA9-4209-BA19-5459F714028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61188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413" y="741395"/>
            <a:ext cx="7667134" cy="46964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110" y="105267"/>
            <a:ext cx="9439370" cy="40692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110" y="5769204"/>
            <a:ext cx="105297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le 2. </a:t>
            </a:r>
            <a:r>
              <a:rPr lang="en-I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 of a completed standard celeration chart for a participant in the intervention group. </a:t>
            </a:r>
          </a:p>
          <a:p>
            <a:r>
              <a:rPr lang="en-IE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e. </a:t>
            </a:r>
            <a:r>
              <a:rPr lang="en-I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rcle </a:t>
            </a:r>
            <a:r>
              <a:rPr lang="en-I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points</a:t>
            </a:r>
            <a:r>
              <a:rPr lang="en-I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 corrects while X-shaped data points indicate </a:t>
            </a:r>
            <a:r>
              <a:rPr lang="en-I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orrects</a:t>
            </a:r>
            <a:r>
              <a:rPr lang="en-I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r errors. Red lines indicate changes in the study phase. The purple line is the aim line and represents the desired level of performance.  </a:t>
            </a:r>
            <a:endParaRPr lang="en-IE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8025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DON, SINÉAD</dc:creator>
  <cp:lastModifiedBy>LYDON, SINÉAD</cp:lastModifiedBy>
  <cp:revision>2</cp:revision>
  <dcterms:created xsi:type="dcterms:W3CDTF">2019-02-21T11:11:35Z</dcterms:created>
  <dcterms:modified xsi:type="dcterms:W3CDTF">2019-02-21T11:17:30Z</dcterms:modified>
</cp:coreProperties>
</file>